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8" r:id="rId3"/>
  </p:sldIdLst>
  <p:sldSz cx="6858000" cy="9144000" type="letter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9" autoAdjust="0"/>
    <p:restoredTop sz="94660"/>
  </p:normalViewPr>
  <p:slideViewPr>
    <p:cSldViewPr snapToGrid="0">
      <p:cViewPr varScale="1">
        <p:scale>
          <a:sx n="85" d="100"/>
          <a:sy n="85" d="100"/>
        </p:scale>
        <p:origin x="28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597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406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029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236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711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971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428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103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666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468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355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CF826-3DC1-4C5E-BB04-710AFC2DB029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B7DD87-2DAC-453B-A9FA-35BE24040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295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6323099"/>
              </p:ext>
            </p:extLst>
          </p:nvPr>
        </p:nvGraphicFramePr>
        <p:xfrm>
          <a:off x="688562" y="806717"/>
          <a:ext cx="4860902" cy="3250276"/>
        </p:xfrm>
        <a:graphic>
          <a:graphicData uri="http://schemas.openxmlformats.org/drawingml/2006/table">
            <a:tbl>
              <a:tblPr firstRow="1" bandRow="1" bandCol="1">
                <a:tableStyleId>{5C22544A-7EE6-4342-B048-85BDC9FD1C3A}</a:tableStyleId>
              </a:tblPr>
              <a:tblGrid>
                <a:gridCol w="1896983">
                  <a:extLst>
                    <a:ext uri="{9D8B030D-6E8A-4147-A177-3AD203B41FA5}">
                      <a16:colId xmlns:a16="http://schemas.microsoft.com/office/drawing/2014/main" val="3233041745"/>
                    </a:ext>
                  </a:extLst>
                </a:gridCol>
                <a:gridCol w="1573701">
                  <a:extLst>
                    <a:ext uri="{9D8B030D-6E8A-4147-A177-3AD203B41FA5}">
                      <a16:colId xmlns:a16="http://schemas.microsoft.com/office/drawing/2014/main" val="2017522553"/>
                    </a:ext>
                  </a:extLst>
                </a:gridCol>
                <a:gridCol w="1390218">
                  <a:extLst>
                    <a:ext uri="{9D8B030D-6E8A-4147-A177-3AD203B41FA5}">
                      <a16:colId xmlns:a16="http://schemas.microsoft.com/office/drawing/2014/main" val="140191597"/>
                    </a:ext>
                  </a:extLst>
                </a:gridCol>
              </a:tblGrid>
              <a:tr h="57013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nent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 country number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lanoma Incidence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lanoma Mortality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2255314"/>
                  </a:ext>
                </a:extLst>
              </a:tr>
              <a:tr h="515007">
                <a:tc>
                  <a:txBody>
                    <a:bodyPr/>
                    <a:lstStyle/>
                    <a:p>
                      <a:pPr marL="0" marR="0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rica (N = 55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007)*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0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9251279"/>
                  </a:ext>
                </a:extLst>
              </a:tr>
              <a:tr h="525518">
                <a:tc>
                  <a:txBody>
                    <a:bodyPr/>
                    <a:lstStyle/>
                    <a:p>
                      <a:pPr marL="0" marR="0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ericas (N = 39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127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0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3037227"/>
                  </a:ext>
                </a:extLst>
              </a:tr>
              <a:tr h="557048">
                <a:tc>
                  <a:txBody>
                    <a:bodyPr/>
                    <a:lstStyle/>
                    <a:p>
                      <a:pPr marL="0" marR="0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ia (N = 48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001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012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0195723"/>
                  </a:ext>
                </a:extLst>
              </a:tr>
              <a:tr h="546538">
                <a:tc>
                  <a:txBody>
                    <a:bodyPr/>
                    <a:lstStyle/>
                    <a:p>
                      <a:pPr marL="0" marR="0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rope (N = 40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&lt;0.001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025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6525895"/>
                  </a:ext>
                </a:extLst>
              </a:tr>
              <a:tr h="536027">
                <a:tc>
                  <a:txBody>
                    <a:bodyPr/>
                    <a:lstStyle/>
                    <a:p>
                      <a:pPr marL="0" marR="0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eania (N = 17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302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015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mbria" panose="020405030504060302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8173267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08151" y="4608384"/>
            <a:ext cx="629146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 Correlations between Select Alcohol Consumption and Melanoma Outcomes in five Continents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source of melanoma incidence (2018), melanoma mortality (2018), and alcohol consumption (2010)  is explained in Fig 1 legend. Spearman’s rank coefficient was utilized to assess correlation due to skewed data and the influence of outliers. P-values were reported based on a null hypothesis of no monotonic association against a two-sided alternative at the 0.05 level. The statistical analysis was conducted using R version 4.0.2 (The R Foundation for Statistical Computing).</a:t>
            </a:r>
          </a:p>
        </p:txBody>
      </p:sp>
      <p:sp>
        <p:nvSpPr>
          <p:cNvPr id="8" name="TextBox 15"/>
          <p:cNvSpPr txBox="1">
            <a:spLocks noChangeArrowheads="1"/>
          </p:cNvSpPr>
          <p:nvPr/>
        </p:nvSpPr>
        <p:spPr bwMode="auto">
          <a:xfrm>
            <a:off x="0" y="506421"/>
            <a:ext cx="745717" cy="2553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r>
              <a:rPr lang="en-US" altLang="en-US" sz="1059" b="1" dirty="0"/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34800237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7843161"/>
              </p:ext>
            </p:extLst>
          </p:nvPr>
        </p:nvGraphicFramePr>
        <p:xfrm>
          <a:off x="149086" y="373287"/>
          <a:ext cx="6578284" cy="660042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451193">
                  <a:extLst>
                    <a:ext uri="{9D8B030D-6E8A-4147-A177-3AD203B41FA5}">
                      <a16:colId xmlns:a16="http://schemas.microsoft.com/office/drawing/2014/main" val="194523698"/>
                    </a:ext>
                  </a:extLst>
                </a:gridCol>
                <a:gridCol w="465338">
                  <a:extLst>
                    <a:ext uri="{9D8B030D-6E8A-4147-A177-3AD203B41FA5}">
                      <a16:colId xmlns:a16="http://schemas.microsoft.com/office/drawing/2014/main" val="921007871"/>
                    </a:ext>
                  </a:extLst>
                </a:gridCol>
                <a:gridCol w="465338">
                  <a:extLst>
                    <a:ext uri="{9D8B030D-6E8A-4147-A177-3AD203B41FA5}">
                      <a16:colId xmlns:a16="http://schemas.microsoft.com/office/drawing/2014/main" val="46759927"/>
                    </a:ext>
                  </a:extLst>
                </a:gridCol>
                <a:gridCol w="465338">
                  <a:extLst>
                    <a:ext uri="{9D8B030D-6E8A-4147-A177-3AD203B41FA5}">
                      <a16:colId xmlns:a16="http://schemas.microsoft.com/office/drawing/2014/main" val="1273317823"/>
                    </a:ext>
                  </a:extLst>
                </a:gridCol>
                <a:gridCol w="832756">
                  <a:extLst>
                    <a:ext uri="{9D8B030D-6E8A-4147-A177-3AD203B41FA5}">
                      <a16:colId xmlns:a16="http://schemas.microsoft.com/office/drawing/2014/main" val="1528368924"/>
                    </a:ext>
                  </a:extLst>
                </a:gridCol>
                <a:gridCol w="2898321">
                  <a:extLst>
                    <a:ext uri="{9D8B030D-6E8A-4147-A177-3AD203B41FA5}">
                      <a16:colId xmlns:a16="http://schemas.microsoft.com/office/drawing/2014/main" val="222940538"/>
                    </a:ext>
                  </a:extLst>
                </a:gridCol>
              </a:tblGrid>
              <a:tr h="13241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orted or studied country (n=23)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DH2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lleles (%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umb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73967338"/>
                  </a:ext>
                </a:extLst>
              </a:tr>
              <a:tr h="132412"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21" marR="6621" marT="66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1/*1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1/*2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2/*2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4481262"/>
                  </a:ext>
                </a:extLst>
              </a:tr>
              <a:tr h="23234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strali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0468197"/>
                  </a:ext>
                </a:extLst>
              </a:tr>
              <a:tr h="2186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zi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99192912"/>
                  </a:ext>
                </a:extLst>
              </a:tr>
              <a:tr h="2186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67597292"/>
                  </a:ext>
                </a:extLst>
              </a:tr>
              <a:tr h="2186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7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34047937"/>
                  </a:ext>
                </a:extLst>
              </a:tr>
              <a:tr h="2186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nla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68581389"/>
                  </a:ext>
                </a:extLst>
              </a:tr>
              <a:tr h="2186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an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04099553"/>
                  </a:ext>
                </a:extLst>
              </a:tr>
              <a:tr h="2186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nga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57205760"/>
                  </a:ext>
                </a:extLst>
              </a:tr>
              <a:tr h="2186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i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1147120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ujii</a:t>
                      </a:r>
                      <a:r>
                        <a:rPr lang="en-US" altLang="ja-JP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et al. Nihon </a:t>
                      </a:r>
                      <a:r>
                        <a:rPr lang="en-US" altLang="ja-JP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rukoru</a:t>
                      </a:r>
                      <a:r>
                        <a:rPr lang="en-US" altLang="ja-JP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Yakubutsu</a:t>
                      </a:r>
                      <a:r>
                        <a:rPr lang="en-US" altLang="ja-JP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gakkai</a:t>
                      </a:r>
                      <a:r>
                        <a:rPr lang="en-US" altLang="ja-JP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Zasshi</a:t>
                      </a:r>
                      <a:r>
                        <a:rPr lang="en-US" altLang="ja-JP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, 33: 683-91, 1998</a:t>
                      </a:r>
                      <a:endParaRPr lang="da-DK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8143086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ore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e et al., Alcohol Clin Exp Res., 21: 953-6, 1997</a:t>
                      </a:r>
                      <a:endParaRPr lang="da-DK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3741075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aysi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7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92597565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xico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47254798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goli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en et al., Alcohol Clin Exp Res., 21: 1272-9, 1997</a:t>
                      </a:r>
                      <a:endParaRPr lang="da-DK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2009695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w Zeala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mbers et al., Alcohol Clin Exp Res 26: 949-55, 200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9099082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pua New Guine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08953754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ilippin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80426131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a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choz-Lach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 et al., </a:t>
                      </a:r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and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J Gastroenterol., 42: 493-98, 20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1696580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a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g KY et al., J Clin Pharm </a:t>
                      </a:r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, 38: 141-49, 20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01012944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wede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9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389694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aila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onyaphiphat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Cancer Lett., 186: 193, 20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37037791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rke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edde</a:t>
                      </a: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Hum Genet., 88: 344-6, 199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77338142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renzo A et al., Drug Alcohol Depend, 84: 195-200, 2006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88259669"/>
                  </a:ext>
                </a:extLst>
              </a:tr>
              <a:tr h="2353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zbekista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hn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S et al., Asian Pac J Cancer Prev., 10: 17-20, 200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21" marR="6621" marT="662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64818271"/>
                  </a:ext>
                </a:extLst>
              </a:tr>
            </a:tbl>
          </a:graphicData>
        </a:graphic>
      </p:graphicFrame>
      <p:sp>
        <p:nvSpPr>
          <p:cNvPr id="3" name="TextBox 15"/>
          <p:cNvSpPr txBox="1">
            <a:spLocks noChangeArrowheads="1"/>
          </p:cNvSpPr>
          <p:nvPr/>
        </p:nvSpPr>
        <p:spPr bwMode="auto">
          <a:xfrm>
            <a:off x="-17608" y="0"/>
            <a:ext cx="745717" cy="2553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r>
              <a:rPr lang="en-US" altLang="en-US" sz="1059" b="1" dirty="0"/>
              <a:t>Table S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18661" y="7345017"/>
            <a:ext cx="62914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 Allele frequencies of ALDH2 gene by countrie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LDH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llele frequencies were searched by “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ubm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” using the combination with “ALDH2,” “alleles,” and “by country,”</a:t>
            </a:r>
          </a:p>
        </p:txBody>
      </p:sp>
    </p:spTree>
    <p:extLst>
      <p:ext uri="{BB962C8B-B14F-4D97-AF65-F5344CB8AC3E}">
        <p14:creationId xmlns:p14="http://schemas.microsoft.com/office/powerpoint/2010/main" val="4116933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4</TotalTime>
  <Words>668</Words>
  <Application>Microsoft Macintosh PowerPoint</Application>
  <PresentationFormat>Letter Paper (8.5x11 in)</PresentationFormat>
  <Paragraphs>18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mauchi, Takeshi</dc:creator>
  <cp:lastModifiedBy>Joshua Dykas</cp:lastModifiedBy>
  <cp:revision>39</cp:revision>
  <cp:lastPrinted>2021-11-04T19:08:45Z</cp:lastPrinted>
  <dcterms:created xsi:type="dcterms:W3CDTF">2021-10-01T17:30:07Z</dcterms:created>
  <dcterms:modified xsi:type="dcterms:W3CDTF">2021-12-01T18:01:40Z</dcterms:modified>
</cp:coreProperties>
</file>